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8002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-36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963440" y="1240920"/>
            <a:ext cx="2870280" cy="3349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76480"/>
            <a:ext cx="5438880" cy="390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6A9973-D66D-4002-9AEF-CD76E06D7896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sldImg"/>
          </p:nvPr>
        </p:nvSpPr>
        <p:spPr>
          <a:xfrm>
            <a:off x="1963800" y="1241280"/>
            <a:ext cx="2870280" cy="3349800"/>
          </a:xfrm>
          <a:prstGeom prst="rect">
            <a:avLst/>
          </a:prstGeom>
          <a:ln w="0">
            <a:noFill/>
          </a:ln>
        </p:spPr>
      </p:sp>
      <p:sp>
        <p:nvSpPr>
          <p:cNvPr id="94" name="PlaceHolder 2"/>
          <p:cNvSpPr>
            <a:spLocks noGrp="1"/>
          </p:cNvSpPr>
          <p:nvPr>
            <p:ph type="body"/>
          </p:nvPr>
        </p:nvSpPr>
        <p:spPr>
          <a:xfrm>
            <a:off x="679320" y="4776480"/>
            <a:ext cx="5438880" cy="390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スライド番号プレースホルダー 3"/>
          <p:cNvSpPr/>
          <p:nvPr/>
        </p:nvSpPr>
        <p:spPr>
          <a:xfrm>
            <a:off x="3849840" y="9428040"/>
            <a:ext cx="2946240" cy="49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0A6AA8-9BD2-4DEA-B6AA-41A19CDA3346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0AD55-D3EA-49B3-B489-04AEF568C5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20760"/>
            <a:ext cx="6172200" cy="133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1866600"/>
            <a:ext cx="617220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4625640"/>
            <a:ext cx="617220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A176F8-8127-4BAF-89BA-CE0426BB08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20760"/>
            <a:ext cx="6172200" cy="133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1866600"/>
            <a:ext cx="301176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1866600"/>
            <a:ext cx="301176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4625640"/>
            <a:ext cx="301176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4625640"/>
            <a:ext cx="301176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670DAA-D80D-4638-ABB1-4AAF5C18BB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20760"/>
            <a:ext cx="6172200" cy="133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1866600"/>
            <a:ext cx="198720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1866600"/>
            <a:ext cx="198720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1866600"/>
            <a:ext cx="198720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4625640"/>
            <a:ext cx="198720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4625640"/>
            <a:ext cx="198720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4625640"/>
            <a:ext cx="198720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3ED78-8B59-4C0E-8FB7-22302F580B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20760"/>
            <a:ext cx="6172200" cy="133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1866600"/>
            <a:ext cx="6172200" cy="5281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7B914-AEEC-4B42-85CA-4A3662F17C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20760"/>
            <a:ext cx="6172200" cy="133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1866600"/>
            <a:ext cx="6172200" cy="528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82DEC-D0DF-45BE-9953-7545765179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20760"/>
            <a:ext cx="6172200" cy="133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1866600"/>
            <a:ext cx="3011760" cy="528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1866600"/>
            <a:ext cx="3011760" cy="528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7453BA-7A5A-4A0F-9F71-EF96443D85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20760"/>
            <a:ext cx="6172200" cy="133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A6E9E-BB99-4989-9B35-2925590071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20760"/>
            <a:ext cx="6172200" cy="6182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062C0B-1898-41FE-AE37-27208975B0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20760"/>
            <a:ext cx="6172200" cy="133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1866600"/>
            <a:ext cx="301176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1866600"/>
            <a:ext cx="3011760" cy="528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4625640"/>
            <a:ext cx="301176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7C2E7D-56B7-4C2E-954C-1026A5E980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20760"/>
            <a:ext cx="6172200" cy="133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1866600"/>
            <a:ext cx="3011760" cy="528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1866600"/>
            <a:ext cx="301176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4625640"/>
            <a:ext cx="301176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8ED279-B00D-4609-AC0C-8B77FFB423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20760"/>
            <a:ext cx="6172200" cy="133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1866600"/>
            <a:ext cx="301176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1866600"/>
            <a:ext cx="301176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4625640"/>
            <a:ext cx="6172200" cy="2519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92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043EAA-E633-456F-A797-5822E0A3F1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20760"/>
            <a:ext cx="6172200" cy="1333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5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1866600"/>
            <a:ext cx="6172200" cy="5281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9000"/>
          </a:bodyPr>
          <a:p>
            <a:pPr marL="355680" indent="-355680">
              <a:spcBef>
                <a:spcPts val="9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1" marL="771480" indent="-296640">
              <a:spcBef>
                <a:spcPts val="9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2" marL="1186560" indent="-237240">
              <a:spcBef>
                <a:spcPts val="924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3" marL="1661400" indent="-237240">
              <a:spcBef>
                <a:spcPts val="924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4" marL="2136240" indent="-23724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5" marL="2136240" indent="-23724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  <a:p>
            <a:pPr lvl="6" marL="2136240" indent="-237240">
              <a:spcBef>
                <a:spcPts val="924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7287840"/>
            <a:ext cx="1600200" cy="55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7287840"/>
            <a:ext cx="2171520" cy="55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7287840"/>
            <a:ext cx="1600200" cy="55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49BE3B-2355-4300-90FD-5759487A265F}" type="slidenum">
              <a:rPr b="0" lang="en-US" sz="1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73"/>
          <p:cNvSpPr/>
          <p:nvPr/>
        </p:nvSpPr>
        <p:spPr>
          <a:xfrm>
            <a:off x="2866320" y="7626240"/>
            <a:ext cx="78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1 Fi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グループ化 1"/>
          <p:cNvGrpSpPr/>
          <p:nvPr/>
        </p:nvGrpSpPr>
        <p:grpSpPr>
          <a:xfrm>
            <a:off x="106200" y="393840"/>
            <a:ext cx="6751800" cy="1639800"/>
            <a:chOff x="106200" y="393840"/>
            <a:chExt cx="6751800" cy="1639800"/>
          </a:xfrm>
        </p:grpSpPr>
        <p:sp>
          <p:nvSpPr>
            <p:cNvPr id="50" name="Text Box 7"/>
            <p:cNvSpPr/>
            <p:nvPr/>
          </p:nvSpPr>
          <p:spPr>
            <a:xfrm>
              <a:off x="1188720" y="542880"/>
              <a:ext cx="3888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3F(43mer)</a:t>
              </a:r>
              <a:br>
                <a:rPr sz="1000"/>
              </a:b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P5’ccggcctggggag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tcgt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gagaa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tC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agttactccgg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8"/>
            <p:cNvSpPr/>
            <p:nvPr/>
          </p:nvSpPr>
          <p:spPr>
            <a:xfrm>
              <a:off x="452160" y="1570320"/>
              <a:ext cx="13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1R(27mer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0"/>
            <p:cNvSpPr/>
            <p:nvPr/>
          </p:nvSpPr>
          <p:spPr>
            <a:xfrm>
              <a:off x="4006800" y="1435320"/>
              <a:ext cx="156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2R(43mer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1"/>
            <p:cNvSpPr/>
            <p:nvPr/>
          </p:nvSpPr>
          <p:spPr>
            <a:xfrm>
              <a:off x="4600440" y="393840"/>
              <a:ext cx="15685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4F(42mer)</a:t>
              </a:r>
              <a:br>
                <a:rPr sz="1000"/>
              </a:b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B5’ccaaatggccgga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43"/>
            <p:cNvSpPr/>
            <p:nvPr/>
          </p:nvSpPr>
          <p:spPr>
            <a:xfrm>
              <a:off x="150480" y="898560"/>
              <a:ext cx="6313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5’-tggacacagtcccccggcctggggag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tcgt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gagaa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ta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agttactccgggccaaatggccgga-3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’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44"/>
            <p:cNvSpPr/>
            <p:nvPr/>
          </p:nvSpPr>
          <p:spPr>
            <a:xfrm rot="10800000">
              <a:off x="106200" y="1053000"/>
              <a:ext cx="622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5’-tccggccatttggcccggagtaact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ta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ttctc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acga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ctccccaggccgggggactgtgtcca-3’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9"/>
            <p:cNvSpPr/>
            <p:nvPr/>
          </p:nvSpPr>
          <p:spPr>
            <a:xfrm>
              <a:off x="3454200" y="601560"/>
              <a:ext cx="836640" cy="222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6760" rIns="86760" tIns="10440" bIns="10440" anchor="ctr">
              <a:normAutofit/>
            </a:bodyPr>
            <a:p>
              <a:pPr algn="just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MseI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  <a:ea typeface="ＭＳ Ｐ明朝"/>
                </a:rPr>
                <a:t>R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 sit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44"/>
            <p:cNvSpPr/>
            <p:nvPr/>
          </p:nvSpPr>
          <p:spPr>
            <a:xfrm rot="10800000">
              <a:off x="1359720" y="1273680"/>
              <a:ext cx="3932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P5’cccggagtaact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Ga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ttctc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ac8a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ctccccaggccg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44"/>
            <p:cNvSpPr/>
            <p:nvPr/>
          </p:nvSpPr>
          <p:spPr>
            <a:xfrm rot="10800000">
              <a:off x="242640" y="1405800"/>
              <a:ext cx="166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B5’gggactgtgtcca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8"/>
            <p:cNvSpPr/>
            <p:nvPr/>
          </p:nvSpPr>
          <p:spPr>
            <a:xfrm>
              <a:off x="6169320" y="959040"/>
              <a:ext cx="68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TK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9"/>
            <p:cNvSpPr/>
            <p:nvPr/>
          </p:nvSpPr>
          <p:spPr>
            <a:xfrm>
              <a:off x="1903320" y="1694160"/>
              <a:ext cx="2171520" cy="339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86760" rIns="86760" tIns="10440" bIns="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A single 8-oxoG site in 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TK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 TS for pvIT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  <a:ea typeface="ＭＳ Ｐ明朝"/>
                </a:rPr>
                <a:t>1x8oG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 vecto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1" name="グループ化 1"/>
          <p:cNvGrpSpPr/>
          <p:nvPr/>
        </p:nvGrpSpPr>
        <p:grpSpPr>
          <a:xfrm>
            <a:off x="110880" y="2600280"/>
            <a:ext cx="6751800" cy="1629000"/>
            <a:chOff x="110880" y="2600280"/>
            <a:chExt cx="6751800" cy="1629000"/>
          </a:xfrm>
        </p:grpSpPr>
        <p:sp>
          <p:nvSpPr>
            <p:cNvPr id="62" name="Text Box 7"/>
            <p:cNvSpPr/>
            <p:nvPr/>
          </p:nvSpPr>
          <p:spPr>
            <a:xfrm>
              <a:off x="1193760" y="2749320"/>
              <a:ext cx="38876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3F(43mer)</a:t>
              </a:r>
              <a:br>
                <a:rPr sz="1000"/>
              </a:b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P5’ccggcctggggag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tcgt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gagaa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tC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agttactccgg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8"/>
            <p:cNvSpPr/>
            <p:nvPr/>
          </p:nvSpPr>
          <p:spPr>
            <a:xfrm>
              <a:off x="457200" y="3776760"/>
              <a:ext cx="13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1R(27mer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10"/>
            <p:cNvSpPr/>
            <p:nvPr/>
          </p:nvSpPr>
          <p:spPr>
            <a:xfrm>
              <a:off x="4011480" y="3641760"/>
              <a:ext cx="1568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2R(43mer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11"/>
            <p:cNvSpPr/>
            <p:nvPr/>
          </p:nvSpPr>
          <p:spPr>
            <a:xfrm>
              <a:off x="4605480" y="2600280"/>
              <a:ext cx="15681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4F(42mer)</a:t>
              </a:r>
              <a:br>
                <a:rPr sz="1000"/>
              </a:b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B5’ccaaatggccgga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43"/>
            <p:cNvSpPr/>
            <p:nvPr/>
          </p:nvSpPr>
          <p:spPr>
            <a:xfrm>
              <a:off x="155520" y="3106800"/>
              <a:ext cx="6313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5’-tggacacagtcccccggcctggggag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tcgt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gagaa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ta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agttactccgggccaaatggccgga-3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’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44"/>
            <p:cNvSpPr/>
            <p:nvPr/>
          </p:nvSpPr>
          <p:spPr>
            <a:xfrm rot="10800000">
              <a:off x="110880" y="3259800"/>
              <a:ext cx="6226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5’-tccggccatttggcccggagtaact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ta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ttctc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acga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ctccccaggccgggggactgtgtcca-3’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19"/>
            <p:cNvSpPr/>
            <p:nvPr/>
          </p:nvSpPr>
          <p:spPr>
            <a:xfrm>
              <a:off x="3459240" y="2808000"/>
              <a:ext cx="836280" cy="222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6760" rIns="86760" tIns="10440" bIns="10440" anchor="ctr">
              <a:normAutofit/>
            </a:bodyPr>
            <a:p>
              <a:pPr algn="just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MseI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  <a:ea typeface="ＭＳ Ｐ明朝"/>
                </a:rPr>
                <a:t>R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 sit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44"/>
            <p:cNvSpPr/>
            <p:nvPr/>
          </p:nvSpPr>
          <p:spPr>
            <a:xfrm rot="10800000">
              <a:off x="1364760" y="3480840"/>
              <a:ext cx="3932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P5’cccggagtaact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Ga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ttctc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ac8a8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ctccccaggccg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44"/>
            <p:cNvSpPr/>
            <p:nvPr/>
          </p:nvSpPr>
          <p:spPr>
            <a:xfrm rot="10800000">
              <a:off x="247680" y="3612600"/>
              <a:ext cx="166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B5’gggactgtgtcca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8"/>
            <p:cNvSpPr/>
            <p:nvPr/>
          </p:nvSpPr>
          <p:spPr>
            <a:xfrm>
              <a:off x="6174000" y="3165480"/>
              <a:ext cx="68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TK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29"/>
            <p:cNvSpPr/>
            <p:nvPr/>
          </p:nvSpPr>
          <p:spPr>
            <a:xfrm>
              <a:off x="1908000" y="3889440"/>
              <a:ext cx="2171520" cy="339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86760" rIns="86760" tIns="10440" bIns="10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Two 8-oxoG sites in 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TK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 TS for pvIT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  <a:ea typeface="ＭＳ Ｐ明朝"/>
                </a:rPr>
                <a:t>2x8oG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 vecto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73" name="直線矢印コネクタ 209"/>
          <p:cNvCxnSpPr/>
          <p:nvPr/>
        </p:nvCxnSpPr>
        <p:spPr>
          <a:xfrm flipV="1">
            <a:off x="2830320" y="1458720"/>
            <a:ext cx="1080" cy="1116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sm" type="arrow" w="sm"/>
          </a:ln>
        </p:spPr>
      </p:cxnSp>
      <p:cxnSp>
        <p:nvCxnSpPr>
          <p:cNvPr id="74" name="直線矢印コネクタ 210"/>
          <p:cNvCxnSpPr/>
          <p:nvPr/>
        </p:nvCxnSpPr>
        <p:spPr>
          <a:xfrm flipV="1">
            <a:off x="2839680" y="3672720"/>
            <a:ext cx="1080" cy="111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sm" type="arrow" w="sm"/>
          </a:ln>
        </p:spPr>
      </p:cxnSp>
      <p:cxnSp>
        <p:nvCxnSpPr>
          <p:cNvPr id="75" name="直線矢印コネクタ 211"/>
          <p:cNvCxnSpPr/>
          <p:nvPr/>
        </p:nvCxnSpPr>
        <p:spPr>
          <a:xfrm flipV="1">
            <a:off x="2680920" y="3669480"/>
            <a:ext cx="1080" cy="111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sm" type="arrow" w="sm"/>
          </a:ln>
        </p:spPr>
      </p:cxnSp>
      <p:grpSp>
        <p:nvGrpSpPr>
          <p:cNvPr id="76" name="グループ化 1"/>
          <p:cNvGrpSpPr/>
          <p:nvPr/>
        </p:nvGrpSpPr>
        <p:grpSpPr>
          <a:xfrm>
            <a:off x="106200" y="5097600"/>
            <a:ext cx="6751800" cy="1420920"/>
            <a:chOff x="106200" y="5097600"/>
            <a:chExt cx="6751800" cy="1420920"/>
          </a:xfrm>
        </p:grpSpPr>
        <p:sp>
          <p:nvSpPr>
            <p:cNvPr id="77" name="Text Box 7"/>
            <p:cNvSpPr/>
            <p:nvPr/>
          </p:nvSpPr>
          <p:spPr>
            <a:xfrm>
              <a:off x="1188720" y="5246640"/>
              <a:ext cx="3888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3F(43mer)</a:t>
              </a:r>
              <a:br>
                <a:rPr sz="1000"/>
              </a:b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P5’ccggcctggggag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tc8t8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gagaa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tC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agttactccgg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8"/>
            <p:cNvSpPr/>
            <p:nvPr/>
          </p:nvSpPr>
          <p:spPr>
            <a:xfrm>
              <a:off x="452160" y="6272280"/>
              <a:ext cx="13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1R(27mer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10"/>
            <p:cNvSpPr/>
            <p:nvPr/>
          </p:nvSpPr>
          <p:spPr>
            <a:xfrm>
              <a:off x="4006800" y="6137280"/>
              <a:ext cx="156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2R(43mer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11"/>
            <p:cNvSpPr/>
            <p:nvPr/>
          </p:nvSpPr>
          <p:spPr>
            <a:xfrm>
              <a:off x="4600440" y="5097600"/>
              <a:ext cx="15685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imer 4F(42mer)</a:t>
              </a:r>
              <a:br>
                <a:rPr sz="1000"/>
              </a:b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B5’ccaaatggccgga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43"/>
            <p:cNvSpPr/>
            <p:nvPr/>
          </p:nvSpPr>
          <p:spPr>
            <a:xfrm>
              <a:off x="150480" y="5602320"/>
              <a:ext cx="6313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5’-tggacacagtcccccggcctggggag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tcgt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gagaa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ta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agttactccgggccaaatggccgga-3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’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44"/>
            <p:cNvSpPr/>
            <p:nvPr/>
          </p:nvSpPr>
          <p:spPr>
            <a:xfrm rot="10800000">
              <a:off x="106200" y="5755320"/>
              <a:ext cx="622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5’-tccggccatttggcccggagtaact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ta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ttctc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acgag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ctccccaggccgggggactgtgtcca-3’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19"/>
            <p:cNvSpPr/>
            <p:nvPr/>
          </p:nvSpPr>
          <p:spPr>
            <a:xfrm>
              <a:off x="3454200" y="5305320"/>
              <a:ext cx="836640" cy="222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86760" rIns="86760" tIns="10440" bIns="10440" anchor="ctr">
              <a:normAutofit/>
            </a:bodyPr>
            <a:p>
              <a:pPr algn="just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MseI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  <a:ea typeface="ＭＳ Ｐ明朝"/>
                </a:rPr>
                <a:t>R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明朝"/>
                </a:rPr>
                <a:t> sit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44"/>
            <p:cNvSpPr/>
            <p:nvPr/>
          </p:nvSpPr>
          <p:spPr>
            <a:xfrm rot="10800000">
              <a:off x="1359720" y="5977800"/>
              <a:ext cx="3932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P5’cccggagtaact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tGaa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ttctcc</a:t>
              </a:r>
              <a:r>
                <a:rPr b="1" lang="en-US" sz="1000" spc="-1" strike="noStrike" u="sng">
                  <a:solidFill>
                    <a:srgbClr val="000000"/>
                  </a:solidFill>
                  <a:uFillTx/>
                  <a:latin typeface="Courier New"/>
                  <a:ea typeface="Courier New"/>
                </a:rPr>
                <a:t>cac8a8</a:t>
              </a: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gctccccaggccg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44"/>
            <p:cNvSpPr/>
            <p:nvPr/>
          </p:nvSpPr>
          <p:spPr>
            <a:xfrm rot="10800000">
              <a:off x="242640" y="6108120"/>
              <a:ext cx="166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B5’gggactgtgtcca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8"/>
            <p:cNvSpPr/>
            <p:nvPr/>
          </p:nvSpPr>
          <p:spPr>
            <a:xfrm>
              <a:off x="6169320" y="5662440"/>
              <a:ext cx="68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TK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87" name="直線矢印コネクタ 223"/>
          <p:cNvCxnSpPr/>
          <p:nvPr/>
        </p:nvCxnSpPr>
        <p:spPr>
          <a:xfrm>
            <a:off x="3084120" y="5338440"/>
            <a:ext cx="1080" cy="111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sm" type="arrow" w="sm"/>
          </a:ln>
        </p:spPr>
      </p:cxnSp>
      <p:cxnSp>
        <p:nvCxnSpPr>
          <p:cNvPr id="88" name="直線矢印コネクタ 224"/>
          <p:cNvCxnSpPr/>
          <p:nvPr/>
        </p:nvCxnSpPr>
        <p:spPr>
          <a:xfrm>
            <a:off x="2925360" y="5335200"/>
            <a:ext cx="1080" cy="111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sm" type="arrow" w="sm"/>
          </a:ln>
        </p:spPr>
      </p:cxnSp>
      <p:sp>
        <p:nvSpPr>
          <p:cNvPr id="89" name="Text Box 52"/>
          <p:cNvSpPr/>
          <p:nvPr/>
        </p:nvSpPr>
        <p:spPr>
          <a:xfrm>
            <a:off x="238320" y="123840"/>
            <a:ext cx="372600" cy="41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2"/>
          <p:cNvSpPr/>
          <p:nvPr/>
        </p:nvSpPr>
        <p:spPr>
          <a:xfrm>
            <a:off x="238320" y="2232000"/>
            <a:ext cx="372600" cy="41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52"/>
          <p:cNvSpPr/>
          <p:nvPr/>
        </p:nvSpPr>
        <p:spPr>
          <a:xfrm>
            <a:off x="238320" y="4451400"/>
            <a:ext cx="372600" cy="41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1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29"/>
          <p:cNvSpPr/>
          <p:nvPr/>
        </p:nvSpPr>
        <p:spPr>
          <a:xfrm>
            <a:off x="2084400" y="4910040"/>
            <a:ext cx="2171520" cy="341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86760" rIns="86760" tIns="10440" bIns="1044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明朝"/>
              </a:rPr>
              <a:t>Two 8-oxoG sites in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明朝"/>
              </a:rPr>
              <a:t>TK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明朝"/>
              </a:rPr>
              <a:t> NTS for pvINT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ＭＳ Ｐ明朝"/>
              </a:rPr>
              <a:t>2x8oG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明朝"/>
              </a:rPr>
              <a:t> vect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05T01:36:27Z</dcterms:created>
  <dc:creator>yamada</dc:creator>
  <dc:description/>
  <dc:language>en-US</dc:language>
  <cp:lastModifiedBy>a-sassa</cp:lastModifiedBy>
  <cp:lastPrinted>2015-05-07T01:52:35Z</cp:lastPrinted>
  <dcterms:modified xsi:type="dcterms:W3CDTF">2015-08-27T00:04:26Z</dcterms:modified>
  <cp:revision>246</cp:revision>
  <dc:subject/>
  <dc:title>スライド 1</dc:title>
</cp:coreProperties>
</file>